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72" y="-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lamak\Desktop\Eriko_ChIP_H3K9me3\ChIP-qPCR_H3K9me3_act1_run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vlamak\Desktop\Eriko_ChIP_H3K9me3\ChIP-qPCR_H3K9me3_dgF_run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lamak\Desktop\Eriko_ChIP_H3K9me3\ChIP-qPCR_H3K9me3_matK_run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lamak\Desktop\Eriko_ChIP_H3K9me3\ChIP-qPCR_H3K9me3_tlh1_run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lamak\Desktop\Eriko_ChIP_H3K9me3\ChIP-qPCR_H3K9me3_SPAC186.04c_run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lamak\Desktop\Eriko_ChIP_H3K9me3\ChIP-qPCR_H3K9me3_SPBPB2B2.18_run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lang="ja-JP"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 dirty="0"/>
              <a:t>H3K9me3 at act1</a:t>
            </a:r>
            <a:endParaRPr lang="ja-JP" sz="1200"/>
          </a:p>
        </c:rich>
      </c:tx>
      <c:layout>
        <c:manualLayout>
          <c:xMode val="edge"/>
          <c:yMode val="edge"/>
          <c:x val="0.29383858267716534"/>
          <c:y val="3.6185914260717413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3520457001698317"/>
          <c:y val="0.19281977252843394"/>
          <c:w val="0.7353836652771345"/>
          <c:h val="0.51371216097987749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act1_1-2'!$E$39:$E$41</c:f>
                <c:numCache>
                  <c:formatCode>General</c:formatCode>
                  <c:ptCount val="3"/>
                  <c:pt idx="0">
                    <c:v>8.281351938705388</c:v>
                  </c:pt>
                  <c:pt idx="1">
                    <c:v>1.8907188984431869</c:v>
                  </c:pt>
                  <c:pt idx="2">
                    <c:v>0.64931904621944891</c:v>
                  </c:pt>
                </c:numCache>
              </c:numRef>
            </c:plus>
            <c:minus>
              <c:numRef>
                <c:f>'% input_act1_1-2'!$E$39:$E$41</c:f>
                <c:numCache>
                  <c:formatCode>General</c:formatCode>
                  <c:ptCount val="3"/>
                  <c:pt idx="0">
                    <c:v>8.281351938705388</c:v>
                  </c:pt>
                  <c:pt idx="1">
                    <c:v>1.8907188984431869</c:v>
                  </c:pt>
                  <c:pt idx="2">
                    <c:v>0.649319046219448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act1_1-2'!$A$39:$A$4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act1_1-2'!$B$39:$B$41</c:f>
              <c:numCache>
                <c:formatCode>0.00000</c:formatCode>
                <c:ptCount val="3"/>
                <c:pt idx="0">
                  <c:v>27.660770388968317</c:v>
                </c:pt>
                <c:pt idx="1">
                  <c:v>5.6684272584801887</c:v>
                </c:pt>
                <c:pt idx="2">
                  <c:v>6.42772182905689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F5-3247-946E-8D5906070572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act1_1-2'!$E$42:$E$44</c:f>
                <c:numCache>
                  <c:formatCode>General</c:formatCode>
                  <c:ptCount val="3"/>
                  <c:pt idx="0">
                    <c:v>4.526576017148761</c:v>
                  </c:pt>
                  <c:pt idx="1">
                    <c:v>0.62766371882974592</c:v>
                  </c:pt>
                  <c:pt idx="2">
                    <c:v>0.26547576272848933</c:v>
                  </c:pt>
                </c:numCache>
              </c:numRef>
            </c:plus>
            <c:minus>
              <c:numRef>
                <c:f>'% input_act1_1-2'!$E$42:$E$44</c:f>
                <c:numCache>
                  <c:formatCode>General</c:formatCode>
                  <c:ptCount val="3"/>
                  <c:pt idx="0">
                    <c:v>4.526576017148761</c:v>
                  </c:pt>
                  <c:pt idx="1">
                    <c:v>0.62766371882974592</c:v>
                  </c:pt>
                  <c:pt idx="2">
                    <c:v>0.26547576272848933</c:v>
                  </c:pt>
                </c:numCache>
              </c:numRef>
            </c:minus>
          </c:errBars>
          <c:val>
            <c:numRef>
              <c:f>'% input_act1_1-2'!$B$42:$B$44</c:f>
              <c:numCache>
                <c:formatCode>0.00000</c:formatCode>
                <c:ptCount val="3"/>
                <c:pt idx="0">
                  <c:v>15.577082737312313</c:v>
                </c:pt>
                <c:pt idx="1">
                  <c:v>7.8368717983308924</c:v>
                </c:pt>
                <c:pt idx="2">
                  <c:v>7.6919880889485857</c:v>
                </c:pt>
              </c:numCache>
            </c:numRef>
          </c:val>
        </c:ser>
        <c:gapWidth val="212"/>
        <c:overlap val="-57"/>
        <c:axId val="75059200"/>
        <c:axId val="75060736"/>
      </c:barChart>
      <c:catAx>
        <c:axId val="7505920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5060736"/>
        <c:crosses val="autoZero"/>
        <c:auto val="1"/>
        <c:lblAlgn val="ctr"/>
        <c:lblOffset val="100"/>
      </c:catAx>
      <c:valAx>
        <c:axId val="75060736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 dirty="0"/>
                  <a:t>% input</a:t>
                </a:r>
              </a:p>
            </c:rich>
          </c:tx>
          <c:layout>
            <c:manualLayout>
              <c:xMode val="edge"/>
              <c:yMode val="edge"/>
              <c:x val="1.4705882352941176E-2"/>
              <c:y val="0.32181452318460191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50592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/>
          <a:lstStyle/>
          <a:p>
            <a:pPr>
              <a:defRPr sz="1200" baseline="0"/>
            </a:pPr>
            <a:endParaRPr lang="sv-SE"/>
          </a:p>
        </c:txPr>
      </c:legendEntry>
      <c:legendEntry>
        <c:idx val="1"/>
        <c:txPr>
          <a:bodyPr/>
          <a:lstStyle/>
          <a:p>
            <a:pPr>
              <a:defRPr sz="1200" baseline="0"/>
            </a:pPr>
            <a:endParaRPr lang="sv-SE"/>
          </a:p>
        </c:txPr>
      </c:legendEntry>
      <c:layout>
        <c:manualLayout>
          <c:xMode val="edge"/>
          <c:yMode val="edge"/>
          <c:x val="0.31898023776439716"/>
          <c:y val="0.83794706911636041"/>
          <c:w val="0.47268865159625639"/>
          <c:h val="9.4867454068241472E-2"/>
        </c:manualLayout>
      </c:layout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lang="ja-JP"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 dirty="0"/>
              <a:t>H3K9me3 at </a:t>
            </a:r>
            <a:r>
              <a:rPr lang="en-US" sz="1200" dirty="0" err="1"/>
              <a:t>dgF</a:t>
            </a:r>
            <a:endParaRPr lang="ja-JP" sz="1200"/>
          </a:p>
        </c:rich>
      </c:tx>
      <c:layout>
        <c:manualLayout>
          <c:xMode val="edge"/>
          <c:yMode val="edge"/>
          <c:x val="0.32274608166250518"/>
          <c:y val="1.6655192020185689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4990485564304463"/>
          <c:y val="0.19281977252843394"/>
          <c:w val="0.72221514590087998"/>
          <c:h val="0.51371216097987749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dgF_1-2'!$E$39:$E$41</c:f>
                <c:numCache>
                  <c:formatCode>General</c:formatCode>
                  <c:ptCount val="3"/>
                  <c:pt idx="0">
                    <c:v>10.87870289789568</c:v>
                  </c:pt>
                  <c:pt idx="1">
                    <c:v>4.6939167238458674</c:v>
                  </c:pt>
                  <c:pt idx="2">
                    <c:v>1.3189079023587262</c:v>
                  </c:pt>
                </c:numCache>
              </c:numRef>
            </c:plus>
            <c:minus>
              <c:numRef>
                <c:f>'% input_dgF_1-2'!$E$39:$E$41</c:f>
                <c:numCache>
                  <c:formatCode>General</c:formatCode>
                  <c:ptCount val="3"/>
                  <c:pt idx="0">
                    <c:v>10.87870289789568</c:v>
                  </c:pt>
                  <c:pt idx="1">
                    <c:v>4.6939167238458674</c:v>
                  </c:pt>
                  <c:pt idx="2">
                    <c:v>1.31890790235872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dgF_1-2'!$A$39:$A$4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dgF_1-2'!$B$39:$B$41</c:f>
              <c:numCache>
                <c:formatCode>0.00000</c:formatCode>
                <c:ptCount val="3"/>
                <c:pt idx="0">
                  <c:v>33.735414318803393</c:v>
                </c:pt>
                <c:pt idx="1">
                  <c:v>13.593797490882366</c:v>
                </c:pt>
                <c:pt idx="2">
                  <c:v>15.3362606368725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F5-3247-946E-8D5906070572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dgF_1-2'!$E$42:$E$44</c:f>
                <c:numCache>
                  <c:formatCode>General</c:formatCode>
                  <c:ptCount val="3"/>
                  <c:pt idx="0">
                    <c:v>8.1961046661826202</c:v>
                  </c:pt>
                  <c:pt idx="1">
                    <c:v>1.4459819910254037</c:v>
                  </c:pt>
                  <c:pt idx="2">
                    <c:v>0.28018018437096193</c:v>
                  </c:pt>
                </c:numCache>
              </c:numRef>
            </c:plus>
            <c:minus>
              <c:numRef>
                <c:f>'% input_dgF_1-2'!$E$42:$E$44</c:f>
                <c:numCache>
                  <c:formatCode>General</c:formatCode>
                  <c:ptCount val="3"/>
                  <c:pt idx="0">
                    <c:v>8.1961046661826202</c:v>
                  </c:pt>
                  <c:pt idx="1">
                    <c:v>1.4459819910254037</c:v>
                  </c:pt>
                  <c:pt idx="2">
                    <c:v>0.28018018437096193</c:v>
                  </c:pt>
                </c:numCache>
              </c:numRef>
            </c:minus>
          </c:errBars>
          <c:val>
            <c:numRef>
              <c:f>'% input_dgF_1-2'!$B$42:$B$44</c:f>
              <c:numCache>
                <c:formatCode>0.00000</c:formatCode>
                <c:ptCount val="3"/>
                <c:pt idx="0">
                  <c:v>28.280650812304565</c:v>
                </c:pt>
                <c:pt idx="1">
                  <c:v>21.258933232781033</c:v>
                </c:pt>
                <c:pt idx="2">
                  <c:v>20.861674778908444</c:v>
                </c:pt>
              </c:numCache>
            </c:numRef>
          </c:val>
        </c:ser>
        <c:gapWidth val="212"/>
        <c:overlap val="-57"/>
        <c:axId val="75394048"/>
        <c:axId val="75424512"/>
      </c:barChart>
      <c:catAx>
        <c:axId val="7539404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5424512"/>
        <c:crosses val="autoZero"/>
        <c:auto val="1"/>
        <c:lblAlgn val="ctr"/>
        <c:lblOffset val="100"/>
      </c:catAx>
      <c:valAx>
        <c:axId val="75424512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 dirty="0"/>
                  <a:t>% input</a:t>
                </a:r>
              </a:p>
            </c:rich>
          </c:tx>
          <c:layout>
            <c:manualLayout>
              <c:xMode val="edge"/>
              <c:yMode val="edge"/>
              <c:x val="1.5625E-2"/>
              <c:y val="0.32181452318460191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5394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/>
          <a:lstStyle/>
          <a:p>
            <a:pPr>
              <a:defRPr sz="1200" baseline="0"/>
            </a:pPr>
            <a:endParaRPr lang="sv-SE"/>
          </a:p>
        </c:txPr>
      </c:legendEntry>
      <c:legendEntry>
        <c:idx val="1"/>
        <c:txPr>
          <a:bodyPr/>
          <a:lstStyle/>
          <a:p>
            <a:pPr>
              <a:defRPr sz="1200" baseline="0"/>
            </a:pPr>
            <a:endParaRPr lang="sv-SE"/>
          </a:p>
        </c:txPr>
      </c:legendEntry>
      <c:layout>
        <c:manualLayout>
          <c:xMode val="edge"/>
          <c:yMode val="edge"/>
          <c:x val="0.32019993824301374"/>
          <c:y val="0.83637489063867021"/>
          <c:w val="0.50037285780453911"/>
          <c:h val="9.632195975503062E-2"/>
        </c:manualLayout>
      </c:layout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lang="ja-JP"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 baseline="0" dirty="0"/>
              <a:t>H3K9me3 at </a:t>
            </a:r>
            <a:r>
              <a:rPr lang="en-US" sz="1200" baseline="0" dirty="0" err="1"/>
              <a:t>matK</a:t>
            </a:r>
            <a:endParaRPr lang="ja-JP" sz="1200" baseline="0"/>
          </a:p>
        </c:rich>
      </c:tx>
      <c:layout>
        <c:manualLayout>
          <c:xMode val="edge"/>
          <c:yMode val="edge"/>
          <c:x val="0.27049512800394576"/>
          <c:y val="1.6655010474785525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3520457001698317"/>
          <c:y val="0.19281977252843394"/>
          <c:w val="0.7353836652771345"/>
          <c:h val="0.51371216097987749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matK_1-2'!$E$39:$E$41</c:f>
                <c:numCache>
                  <c:formatCode>General</c:formatCode>
                  <c:ptCount val="3"/>
                  <c:pt idx="0">
                    <c:v>3.8562326346608153</c:v>
                  </c:pt>
                  <c:pt idx="1">
                    <c:v>3.6877216373251547</c:v>
                  </c:pt>
                  <c:pt idx="2">
                    <c:v>0.81689018404513392</c:v>
                  </c:pt>
                </c:numCache>
              </c:numRef>
            </c:plus>
            <c:minus>
              <c:numRef>
                <c:f>'% input_matK_1-2'!$E$39:$E$41</c:f>
                <c:numCache>
                  <c:formatCode>General</c:formatCode>
                  <c:ptCount val="3"/>
                  <c:pt idx="0">
                    <c:v>3.8562326346608153</c:v>
                  </c:pt>
                  <c:pt idx="1">
                    <c:v>3.6877216373251547</c:v>
                  </c:pt>
                  <c:pt idx="2">
                    <c:v>0.816890184045133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matK_1-2'!$A$39:$A$4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matK_1-2'!$B$39:$B$41</c:f>
              <c:numCache>
                <c:formatCode>0.00000</c:formatCode>
                <c:ptCount val="3"/>
                <c:pt idx="0">
                  <c:v>22.442679248285856</c:v>
                </c:pt>
                <c:pt idx="1">
                  <c:v>7.2820413293543034</c:v>
                </c:pt>
                <c:pt idx="2">
                  <c:v>9.76302683240735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F5-3247-946E-8D5906070572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matK_1-2'!$E$42:$E$44</c:f>
                <c:numCache>
                  <c:formatCode>General</c:formatCode>
                  <c:ptCount val="3"/>
                  <c:pt idx="0">
                    <c:v>6.7606290070945638</c:v>
                  </c:pt>
                  <c:pt idx="1">
                    <c:v>0.84164717964662361</c:v>
                  </c:pt>
                  <c:pt idx="2">
                    <c:v>0.58292407924144751</c:v>
                  </c:pt>
                </c:numCache>
              </c:numRef>
            </c:plus>
            <c:minus>
              <c:numRef>
                <c:f>'% input_matK_1-2'!$E$42:$E$44</c:f>
                <c:numCache>
                  <c:formatCode>General</c:formatCode>
                  <c:ptCount val="3"/>
                  <c:pt idx="0">
                    <c:v>6.7606290070945638</c:v>
                  </c:pt>
                  <c:pt idx="1">
                    <c:v>0.84164717964662361</c:v>
                  </c:pt>
                  <c:pt idx="2">
                    <c:v>0.58292407924144751</c:v>
                  </c:pt>
                </c:numCache>
              </c:numRef>
            </c:minus>
          </c:errBars>
          <c:val>
            <c:numRef>
              <c:f>'% input_matK_1-2'!$B$42:$B$44</c:f>
              <c:numCache>
                <c:formatCode>0.00000</c:formatCode>
                <c:ptCount val="3"/>
                <c:pt idx="0">
                  <c:v>22.556650193367076</c:v>
                </c:pt>
                <c:pt idx="1">
                  <c:v>13.050364717676</c:v>
                </c:pt>
                <c:pt idx="2">
                  <c:v>11.451753279958277</c:v>
                </c:pt>
              </c:numCache>
            </c:numRef>
          </c:val>
        </c:ser>
        <c:gapWidth val="212"/>
        <c:overlap val="-57"/>
        <c:axId val="80317440"/>
        <c:axId val="80329728"/>
      </c:barChart>
      <c:catAx>
        <c:axId val="8031744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0329728"/>
        <c:crosses val="autoZero"/>
        <c:auto val="1"/>
        <c:lblAlgn val="ctr"/>
        <c:lblOffset val="100"/>
      </c:catAx>
      <c:valAx>
        <c:axId val="80329728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 baseline="0"/>
                  <a:t>% input</a:t>
                </a:r>
              </a:p>
            </c:rich>
          </c:tx>
          <c:layout>
            <c:manualLayout>
              <c:xMode val="edge"/>
              <c:yMode val="edge"/>
              <c:x val="1.4705882352941176E-2"/>
              <c:y val="0.32181452318460191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031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539717461787867"/>
          <c:y val="0.83794706911636041"/>
          <c:w val="0.46346789506827513"/>
          <c:h val="9.4867454068241472E-2"/>
        </c:manualLayout>
      </c:layout>
      <c:txPr>
        <a:bodyPr/>
        <a:lstStyle/>
        <a:p>
          <a:pPr>
            <a:defRPr sz="1200" baseline="0"/>
          </a:pPr>
          <a:endParaRPr lang="sv-SE"/>
        </a:p>
      </c:txPr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sv-SE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 b="0" i="0" baseline="0" dirty="0">
                <a:effectLst/>
              </a:rPr>
              <a:t>H3K9me3 at tlh1</a:t>
            </a:r>
          </a:p>
        </c:rich>
      </c:tx>
      <c:layout>
        <c:manualLayout>
          <c:xMode val="edge"/>
          <c:yMode val="edge"/>
          <c:x val="0.32296677588651224"/>
          <c:y val="3.0682414698162731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3520466080155195"/>
          <c:y val="0.19281977252843394"/>
          <c:w val="0.73538356314017417"/>
          <c:h val="0.51371216097987749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tlh1_1-2'!$E$39:$E$41</c:f>
                <c:numCache>
                  <c:formatCode>General</c:formatCode>
                  <c:ptCount val="3"/>
                  <c:pt idx="0">
                    <c:v>7.5604868299031729</c:v>
                  </c:pt>
                  <c:pt idx="1">
                    <c:v>2.481554755573983</c:v>
                  </c:pt>
                  <c:pt idx="2">
                    <c:v>1.524406956372431</c:v>
                  </c:pt>
                </c:numCache>
              </c:numRef>
            </c:plus>
            <c:minus>
              <c:numRef>
                <c:f>'% input_tlh1_1-2'!$E$39:$E$41</c:f>
                <c:numCache>
                  <c:formatCode>General</c:formatCode>
                  <c:ptCount val="3"/>
                  <c:pt idx="0">
                    <c:v>7.5604868299031729</c:v>
                  </c:pt>
                  <c:pt idx="1">
                    <c:v>2.481554755573983</c:v>
                  </c:pt>
                  <c:pt idx="2">
                    <c:v>1.5244069563724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tlh1_1-2'!$A$49:$A$5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tlh1_1-2'!$B$39:$B$41</c:f>
              <c:numCache>
                <c:formatCode>0.00000</c:formatCode>
                <c:ptCount val="3"/>
                <c:pt idx="0">
                  <c:v>27.747083888606539</c:v>
                </c:pt>
                <c:pt idx="1">
                  <c:v>8.9733219176115089</c:v>
                </c:pt>
                <c:pt idx="2">
                  <c:v>11.4440002948927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995-9B4D-BB44-91557AD404A5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tlh1_1-2'!$E$42:$E$44</c:f>
                <c:numCache>
                  <c:formatCode>General</c:formatCode>
                  <c:ptCount val="3"/>
                  <c:pt idx="0">
                    <c:v>7.1918071703155642</c:v>
                  </c:pt>
                  <c:pt idx="1">
                    <c:v>1.1784025796699866</c:v>
                  </c:pt>
                  <c:pt idx="2">
                    <c:v>2.2443270864212361</c:v>
                  </c:pt>
                </c:numCache>
              </c:numRef>
            </c:plus>
            <c:minus>
              <c:numRef>
                <c:f>'% input_tlh1_1-2'!$E$42:$E$44</c:f>
                <c:numCache>
                  <c:formatCode>General</c:formatCode>
                  <c:ptCount val="3"/>
                  <c:pt idx="0">
                    <c:v>7.1918071703155642</c:v>
                  </c:pt>
                  <c:pt idx="1">
                    <c:v>1.1784025796699866</c:v>
                  </c:pt>
                  <c:pt idx="2">
                    <c:v>2.2443270864212361</c:v>
                  </c:pt>
                </c:numCache>
              </c:numRef>
            </c:minus>
          </c:errBars>
          <c:val>
            <c:numRef>
              <c:f>'% input_tlh1_1-2'!$B$42:$B$44</c:f>
              <c:numCache>
                <c:formatCode>0.00000</c:formatCode>
                <c:ptCount val="3"/>
                <c:pt idx="0">
                  <c:v>24.825844963342242</c:v>
                </c:pt>
                <c:pt idx="1">
                  <c:v>13.742824191900148</c:v>
                </c:pt>
                <c:pt idx="2">
                  <c:v>17.185927802569189</c:v>
                </c:pt>
              </c:numCache>
            </c:numRef>
          </c:val>
        </c:ser>
        <c:gapWidth val="219"/>
        <c:overlap val="-27"/>
        <c:axId val="74767360"/>
        <c:axId val="75037696"/>
      </c:barChart>
      <c:catAx>
        <c:axId val="74767360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5037696"/>
        <c:crosses val="autoZero"/>
        <c:auto val="1"/>
        <c:lblAlgn val="ctr"/>
        <c:lblOffset val="100"/>
      </c:catAx>
      <c:valAx>
        <c:axId val="75037696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sz="1200" baseline="0"/>
                  <a:t>% input</a:t>
                </a:r>
              </a:p>
            </c:rich>
          </c:tx>
          <c:layout>
            <c:manualLayout>
              <c:xMode val="edge"/>
              <c:yMode val="edge"/>
              <c:x val="1.4705888029136957E-2"/>
              <c:y val="0.32181452318460191"/>
            </c:manualLayout>
          </c:layout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74767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989552257816994"/>
          <c:y val="0.83768722659667549"/>
          <c:w val="0.50136425095115444"/>
          <c:h val="9.5070428696412954E-2"/>
        </c:manualLayout>
      </c:layout>
      <c:txPr>
        <a:bodyPr/>
        <a:lstStyle/>
        <a:p>
          <a:pPr>
            <a:defRPr sz="1200" baseline="0"/>
          </a:pPr>
          <a:endParaRPr lang="sv-SE"/>
        </a:p>
      </c:txPr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6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 dirty="0"/>
              <a:t>H3K9me3 at SPAC186.04c</a:t>
            </a:r>
            <a:endParaRPr lang="ja-JP" sz="1200"/>
          </a:p>
        </c:rich>
      </c:tx>
      <c:layout>
        <c:manualLayout>
          <c:xMode val="edge"/>
          <c:yMode val="edge"/>
          <c:x val="0.18443473374279001"/>
          <c:y val="1.9519253690983361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5971437393855179"/>
          <c:y val="0.19281985687657782"/>
          <c:w val="0.71087386135556585"/>
          <c:h val="0.51371194825544542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SPAC186.04c_1-2'!$E$39:$E$41</c:f>
                <c:numCache>
                  <c:formatCode>General</c:formatCode>
                  <c:ptCount val="3"/>
                  <c:pt idx="0">
                    <c:v>5.3184646022514146</c:v>
                  </c:pt>
                  <c:pt idx="1">
                    <c:v>1.7697892429931594</c:v>
                  </c:pt>
                  <c:pt idx="2">
                    <c:v>0.84341971193214316</c:v>
                  </c:pt>
                </c:numCache>
              </c:numRef>
            </c:plus>
            <c:minus>
              <c:numRef>
                <c:f>'% input_SPAC186.04c_1-2'!$E$39:$E$41</c:f>
                <c:numCache>
                  <c:formatCode>General</c:formatCode>
                  <c:ptCount val="3"/>
                  <c:pt idx="0">
                    <c:v>5.3184646022514146</c:v>
                  </c:pt>
                  <c:pt idx="1">
                    <c:v>1.7697892429931594</c:v>
                  </c:pt>
                  <c:pt idx="2">
                    <c:v>0.843419711932143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SPAC186.04c_1-2'!$A$39:$A$4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SPAC186.04c_1-2'!$B$39:$B$41</c:f>
              <c:numCache>
                <c:formatCode>0.00000</c:formatCode>
                <c:ptCount val="3"/>
                <c:pt idx="0">
                  <c:v>14.554135736957624</c:v>
                </c:pt>
                <c:pt idx="1">
                  <c:v>6.5339699400254787</c:v>
                </c:pt>
                <c:pt idx="2">
                  <c:v>6.95548006399258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F5-3247-946E-8D5906070572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SPAC186.04c_1-2'!$E$42:$E$44</c:f>
                <c:numCache>
                  <c:formatCode>General</c:formatCode>
                  <c:ptCount val="3"/>
                  <c:pt idx="0">
                    <c:v>6.5038519919343729</c:v>
                  </c:pt>
                  <c:pt idx="1">
                    <c:v>1.1402783600315123</c:v>
                  </c:pt>
                  <c:pt idx="2">
                    <c:v>0.71441339918898117</c:v>
                  </c:pt>
                </c:numCache>
              </c:numRef>
            </c:plus>
            <c:minus>
              <c:numRef>
                <c:f>'% input_SPAC186.04c_1-2'!$E$42:$E$44</c:f>
                <c:numCache>
                  <c:formatCode>General</c:formatCode>
                  <c:ptCount val="3"/>
                  <c:pt idx="0">
                    <c:v>6.5038519919343729</c:v>
                  </c:pt>
                  <c:pt idx="1">
                    <c:v>1.1402783600315123</c:v>
                  </c:pt>
                  <c:pt idx="2">
                    <c:v>0.71441339918898117</c:v>
                  </c:pt>
                </c:numCache>
              </c:numRef>
            </c:minus>
          </c:errBars>
          <c:val>
            <c:numRef>
              <c:f>'% input_SPAC186.04c_1-2'!$B$42:$B$44</c:f>
              <c:numCache>
                <c:formatCode>0.00000</c:formatCode>
                <c:ptCount val="3"/>
                <c:pt idx="0">
                  <c:v>23.682190270480529</c:v>
                </c:pt>
                <c:pt idx="1">
                  <c:v>17.741749627052492</c:v>
                </c:pt>
                <c:pt idx="2">
                  <c:v>17.437852174805787</c:v>
                </c:pt>
              </c:numCache>
            </c:numRef>
          </c:val>
        </c:ser>
        <c:gapWidth val="212"/>
        <c:overlap val="-57"/>
        <c:axId val="82687488"/>
        <c:axId val="82689408"/>
      </c:barChart>
      <c:catAx>
        <c:axId val="8268748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2689408"/>
        <c:crosses val="autoZero"/>
        <c:auto val="1"/>
        <c:lblAlgn val="ctr"/>
        <c:lblOffset val="100"/>
      </c:catAx>
      <c:valAx>
        <c:axId val="82689408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/>
                  <a:t>% input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2687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539717461787867"/>
          <c:y val="0.83794699822703334"/>
          <c:w val="0.47311409603211363"/>
          <c:h val="9.4867495567583365E-2"/>
        </c:manualLayout>
      </c:layout>
      <c:txPr>
        <a:bodyPr/>
        <a:lstStyle/>
        <a:p>
          <a:pPr>
            <a:defRPr sz="1200" baseline="0"/>
          </a:pPr>
          <a:endParaRPr lang="sv-SE"/>
        </a:p>
      </c:txPr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v-SE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 sz="1200"/>
              <a:t>H3K9me3 at SPBPB2B2.18</a:t>
            </a:r>
            <a:endParaRPr lang="ja-JP" sz="1200"/>
          </a:p>
        </c:rich>
      </c:tx>
      <c:layout>
        <c:manualLayout>
          <c:xMode val="edge"/>
          <c:yMode val="edge"/>
          <c:x val="0.10889735250484994"/>
          <c:y val="2.0720184367197979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25971437393855179"/>
          <c:y val="0.19281977252843394"/>
          <c:w val="0.71087386135556585"/>
          <c:h val="0.51371216097987749"/>
        </c:manualLayout>
      </c:layout>
      <c:barChart>
        <c:barDir val="col"/>
        <c:grouping val="clustered"/>
        <c:ser>
          <c:idx val="0"/>
          <c:order val="0"/>
          <c:tx>
            <c:v>WT</c:v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% input_SPBPB2B2.18_1-2'!$E$39:$E$41</c:f>
                <c:numCache>
                  <c:formatCode>General</c:formatCode>
                  <c:ptCount val="3"/>
                  <c:pt idx="0">
                    <c:v>4.8805920977190631</c:v>
                  </c:pt>
                  <c:pt idx="1">
                    <c:v>1.170219753579818</c:v>
                  </c:pt>
                  <c:pt idx="2">
                    <c:v>0.64147683660725252</c:v>
                  </c:pt>
                </c:numCache>
              </c:numRef>
            </c:plus>
            <c:minus>
              <c:numRef>
                <c:f>'% input_SPBPB2B2.18_1-2'!$E$39:$E$41</c:f>
                <c:numCache>
                  <c:formatCode>General</c:formatCode>
                  <c:ptCount val="3"/>
                  <c:pt idx="0">
                    <c:v>4.8805920977190631</c:v>
                  </c:pt>
                  <c:pt idx="1">
                    <c:v>1.170219753579818</c:v>
                  </c:pt>
                  <c:pt idx="2">
                    <c:v>0.641476836607252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% input_SPBPB2B2.18_1-2'!$A$39:$A$44</c:f>
              <c:strCache>
                <c:ptCount val="6"/>
                <c:pt idx="0">
                  <c:v>T0</c:v>
                </c:pt>
                <c:pt idx="1">
                  <c:v>T24</c:v>
                </c:pt>
                <c:pt idx="2">
                  <c:v>T48</c:v>
                </c:pt>
                <c:pt idx="3">
                  <c:v>T0</c:v>
                </c:pt>
                <c:pt idx="4">
                  <c:v>T24</c:v>
                </c:pt>
                <c:pt idx="5">
                  <c:v>T48</c:v>
                </c:pt>
              </c:strCache>
            </c:strRef>
          </c:cat>
          <c:val>
            <c:numRef>
              <c:f>'% input_SPBPB2B2.18_1-2'!$B$39:$B$41</c:f>
              <c:numCache>
                <c:formatCode>0.00000</c:formatCode>
                <c:ptCount val="3"/>
                <c:pt idx="0">
                  <c:v>10.898858353597101</c:v>
                </c:pt>
                <c:pt idx="1">
                  <c:v>3.2374762990205248</c:v>
                </c:pt>
                <c:pt idx="2">
                  <c:v>3.85853046842331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F5-3247-946E-8D5906070572}"/>
            </c:ext>
          </c:extLst>
        </c:ser>
        <c:ser>
          <c:idx val="1"/>
          <c:order val="1"/>
          <c:tx>
            <c:v>leo1D</c:v>
          </c:tx>
          <c:errBars>
            <c:errBarType val="both"/>
            <c:errValType val="cust"/>
            <c:plus>
              <c:numRef>
                <c:f>'% input_SPBPB2B2.18_1-2'!$E$42:$E$44</c:f>
                <c:numCache>
                  <c:formatCode>General</c:formatCode>
                  <c:ptCount val="3"/>
                  <c:pt idx="0">
                    <c:v>4.2785456722367883</c:v>
                  </c:pt>
                  <c:pt idx="1">
                    <c:v>0.88415873845273352</c:v>
                  </c:pt>
                  <c:pt idx="2">
                    <c:v>0.81527014597449399</c:v>
                  </c:pt>
                </c:numCache>
              </c:numRef>
            </c:plus>
            <c:minus>
              <c:numRef>
                <c:f>'% input_SPBPB2B2.18_1-2'!$E$42:$E$44</c:f>
                <c:numCache>
                  <c:formatCode>General</c:formatCode>
                  <c:ptCount val="3"/>
                  <c:pt idx="0">
                    <c:v>4.2785456722367883</c:v>
                  </c:pt>
                  <c:pt idx="1">
                    <c:v>0.88415873845273352</c:v>
                  </c:pt>
                  <c:pt idx="2">
                    <c:v>0.81527014597449399</c:v>
                  </c:pt>
                </c:numCache>
              </c:numRef>
            </c:minus>
          </c:errBars>
          <c:val>
            <c:numRef>
              <c:f>'% input_SPBPB2B2.18_1-2'!$B$42:$B$44</c:f>
              <c:numCache>
                <c:formatCode>0.00000</c:formatCode>
                <c:ptCount val="3"/>
                <c:pt idx="0">
                  <c:v>11.92778204679168</c:v>
                </c:pt>
                <c:pt idx="1">
                  <c:v>7.9365830512876636</c:v>
                </c:pt>
                <c:pt idx="2">
                  <c:v>6.8251878801328267</c:v>
                </c:pt>
              </c:numCache>
            </c:numRef>
          </c:val>
        </c:ser>
        <c:gapWidth val="212"/>
        <c:overlap val="-57"/>
        <c:axId val="87268352"/>
        <c:axId val="87287680"/>
      </c:barChart>
      <c:catAx>
        <c:axId val="87268352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7287680"/>
        <c:crosses val="autoZero"/>
        <c:auto val="1"/>
        <c:lblAlgn val="ctr"/>
        <c:lblOffset val="100"/>
      </c:catAx>
      <c:valAx>
        <c:axId val="87287680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Helvetica" pitchFamily="2" charset="0"/>
                    <a:ea typeface="+mn-ea"/>
                    <a:cs typeface="+mn-cs"/>
                  </a:defRPr>
                </a:pPr>
                <a:r>
                  <a:rPr lang="en-US" altLang="ja-JP" sz="1200"/>
                  <a:t>% input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0" sourceLinked="0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sv-SE"/>
          </a:p>
        </c:txPr>
        <c:crossAx val="87268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7480893932376103"/>
          <c:y val="0.83794706911636041"/>
          <c:w val="0.4473591168750965"/>
          <c:h val="9.4867454068241472E-2"/>
        </c:manualLayout>
      </c:layout>
      <c:txPr>
        <a:bodyPr/>
        <a:lstStyle/>
        <a:p>
          <a:pPr>
            <a:defRPr sz="1200"/>
          </a:pPr>
          <a:endParaRPr lang="sv-SE"/>
        </a:p>
      </c:txPr>
    </c:legend>
    <c:plotVisOnly val="1"/>
    <c:dispBlanksAs val="gap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0" i="0">
          <a:latin typeface="Helvetica" pitchFamily="2" charset="0"/>
        </a:defRPr>
      </a:pPr>
      <a:endParaRPr lang="sv-SE"/>
    </a:p>
  </c:txPr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6471</cdr:x>
      <cdr:y>0.43333</cdr:y>
    </cdr:from>
    <cdr:to>
      <cdr:x>0.91176</cdr:x>
      <cdr:y>0.43333</cdr:y>
    </cdr:to>
    <cdr:cxnSp macro="">
      <cdr:nvCxnSpPr>
        <cdr:cNvPr id="2" name="Straight Connector 1"/>
        <cdr:cNvCxnSpPr/>
      </cdr:nvCxnSpPr>
      <cdr:spPr>
        <a:xfrm xmlns:a="http://schemas.openxmlformats.org/drawingml/2006/main">
          <a:off x="1981200" y="990600"/>
          <a:ext cx="381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12700" cap="flat" cmpd="sng" algn="ctr">
          <a:solidFill>
            <a:sysClr val="windowText" lastClr="000000"/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6471</cdr:x>
      <cdr:y>0.33333</cdr:y>
    </cdr:from>
    <cdr:to>
      <cdr:x>0.94118</cdr:x>
      <cdr:y>0.45451</cdr:y>
    </cdr:to>
    <cdr:sp macro="" textlink="">
      <cdr:nvSpPr>
        <cdr:cNvPr id="3" name="TextBox 16"/>
        <cdr:cNvSpPr txBox="1"/>
      </cdr:nvSpPr>
      <cdr:spPr>
        <a:xfrm xmlns:a="http://schemas.openxmlformats.org/drawingml/2006/main">
          <a:off x="1981200" y="762000"/>
          <a:ext cx="457200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sz="1200" dirty="0" smtClean="0"/>
            <a:t>NS</a:t>
          </a:r>
          <a:endParaRPr lang="sv-SE" sz="12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381000" y="152400"/>
          <a:ext cx="25908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グラフ 5">
            <a:extLst>
              <a:ext uri="{FF2B5EF4-FFF2-40B4-BE49-F238E27FC236}">
                <a16:creationId xmlns:lc="http://schemas.openxmlformats.org/drawingml/2006/lockedCanvas" xmlns:a16="http://schemas.microsoft.com/office/drawing/2014/main" xmlns="" xmlns:xdr="http://schemas.openxmlformats.org/drawingml/2006/spreadsheetDrawing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2971800" y="152400"/>
          <a:ext cx="25908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5486400" y="152400"/>
          <a:ext cx="25908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7">
            <a:extLst>
              <a:ext uri="{FF2B5EF4-FFF2-40B4-BE49-F238E27FC236}">
                <a16:creationId xmlns:lc="http://schemas.openxmlformats.org/drawingml/2006/lockedCanvas" xmlns:a16="http://schemas.microsoft.com/office/drawing/2014/main" xmlns="" xmlns:xdr="http://schemas.openxmlformats.org/drawingml/2006/spreadsheetDrawing" id="{00000000-0008-0000-0300-000003000000}"/>
              </a:ext>
            </a:extLst>
          </p:cNvPr>
          <p:cNvGraphicFramePr>
            <a:graphicFrameLocks/>
          </p:cNvGraphicFramePr>
          <p:nvPr/>
        </p:nvGraphicFramePr>
        <p:xfrm>
          <a:off x="381000" y="2514600"/>
          <a:ext cx="2590799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グラフ 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2971800" y="2514601"/>
          <a:ext cx="2590800" cy="2285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グラフ 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00000000-0008-0000-0300-000002000000}"/>
              </a:ext>
            </a:extLst>
          </p:cNvPr>
          <p:cNvGraphicFramePr>
            <a:graphicFrameLocks/>
          </p:cNvGraphicFramePr>
          <p:nvPr/>
        </p:nvGraphicFramePr>
        <p:xfrm>
          <a:off x="5486400" y="2514600"/>
          <a:ext cx="25908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685801" y="5334000"/>
            <a:ext cx="7239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latin typeface="Times New Roman" pitchFamily="18" charset="0"/>
                <a:cs typeface="Times New Roman" pitchFamily="18" charset="0"/>
              </a:rPr>
              <a:t>Figure S10. Leo1 affects the dynamics of H3K9me3 at subtelomeres. % input of ChIP data from two biological replicates are shown. The p values are from independent  samples t-test comparing  the mean values between wt and leo1</a:t>
            </a:r>
            <a:r>
              <a:rPr lang="el-GR" smtClean="0">
                <a:latin typeface="Times New Roman" pitchFamily="18" charset="0"/>
                <a:cs typeface="Times New Roman" pitchFamily="18" charset="0"/>
              </a:rPr>
              <a:t>Δ</a:t>
            </a:r>
            <a:r>
              <a:rPr lang="sv-SE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sv-SE" dirty="0" smtClean="0">
                <a:latin typeface="Times New Roman" pitchFamily="18" charset="0"/>
                <a:cs typeface="Times New Roman" pitchFamily="18" charset="0"/>
              </a:rPr>
              <a:t>mutant at the different time points. (NS) Non-significant; (*) p value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&lt; 0.05; </a:t>
            </a:r>
            <a:r>
              <a:rPr lang="sv-SE" dirty="0" smtClean="0">
                <a:latin typeface="Times New Roman" pitchFamily="18" charset="0"/>
                <a:cs typeface="Times New Roman" pitchFamily="18" charset="0"/>
              </a:rPr>
              <a:t>(**) </a:t>
            </a:r>
            <a:r>
              <a:rPr lang="sv-SE" dirty="0" smtClean="0">
                <a:latin typeface="Times New Roman" pitchFamily="18" charset="0"/>
                <a:cs typeface="Times New Roman" pitchFamily="18" charset="0"/>
              </a:rPr>
              <a:t>p value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&lt;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0.1.</a:t>
            </a:r>
            <a:endParaRPr lang="sv-SE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1752600" y="35814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752600" y="33528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4343400" y="3505199"/>
            <a:ext cx="381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419600" y="3276600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</a:t>
            </a:r>
            <a:endParaRPr lang="sv-SE" sz="12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4953000" y="3505199"/>
            <a:ext cx="38100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029200" y="3276600"/>
            <a:ext cx="3000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</a:t>
            </a:r>
            <a:endParaRPr lang="sv-SE" sz="1200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1752600" y="14478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752600" y="12192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2362200" y="14478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2362200" y="12192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2362200" y="3505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362200" y="3276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343400" y="11430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343400" y="9144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6858000" y="1219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6858000" y="990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7467600" y="1219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7467600" y="990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6858000" y="3505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6858000" y="3276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*</a:t>
            </a:r>
            <a:endParaRPr lang="sv-SE" sz="1200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7467600" y="3505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7467600" y="3276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1066800" y="29718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066800" y="27432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1066800" y="6858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066800" y="4572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3733800" y="6858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3733800" y="4572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6172200" y="7620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6172200" y="5334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54" name="Straight Connector 53"/>
          <p:cNvCxnSpPr/>
          <p:nvPr/>
        </p:nvCxnSpPr>
        <p:spPr>
          <a:xfrm>
            <a:off x="3733800" y="31242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3733800" y="28956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  <p:cxnSp>
        <p:nvCxnSpPr>
          <p:cNvPr id="56" name="Straight Connector 55"/>
          <p:cNvCxnSpPr/>
          <p:nvPr/>
        </p:nvCxnSpPr>
        <p:spPr>
          <a:xfrm>
            <a:off x="6248400" y="3048000"/>
            <a:ext cx="381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248400" y="2819400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S</a:t>
            </a:r>
            <a:endParaRPr lang="sv-SE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</TotalTime>
  <Words>113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ladimir Maksimov</dc:creator>
  <cp:lastModifiedBy>Vladimir Maksimov</cp:lastModifiedBy>
  <cp:revision>26</cp:revision>
  <dcterms:created xsi:type="dcterms:W3CDTF">2006-08-16T00:00:00Z</dcterms:created>
  <dcterms:modified xsi:type="dcterms:W3CDTF">2019-05-27T15:46:13Z</dcterms:modified>
</cp:coreProperties>
</file>